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46211A-4F7C-9741-B5F8-4300C6E5CE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81EF93-AC51-D87F-78E0-6E720CE0B3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98C52D-057C-A171-309B-DE7731C13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E75F73-6E57-C771-92EC-22781096F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F047BB-9DAD-CECF-9FB6-D48398286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410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600599-1167-2618-7E4E-31D8D6108B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E8CFB5-FD08-4D0C-43F2-11E5A7943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12E7AD-464E-6385-F4E0-C3F5DE9AA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8B4CF0-B11E-C0DA-E3BC-B78080365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3A74FE-F56A-393F-9567-8674FEA23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662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E84B0F2-B9C1-C932-659C-C2952ABE41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C25C83-2BBE-E865-E1DF-6059CFDD62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11274D-534C-CF5B-80FB-57E0C2FAB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BC1398-8582-547D-FB6D-7A1DE8DF8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75C5F5-DC7F-7C94-B7A8-CF157EBDD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129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9799F5-D275-A8C4-5958-65A4043A1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960DAC-FA68-9369-3E8F-328E2AF57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EB0507-0601-03F9-BF4A-A791BCBBA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5D9BF3-6C12-BF9F-B940-CFE532C40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C55308-729B-591F-205A-49C5BEE8A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961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D8326-E737-17B6-B225-548C545E7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95EB06-0190-593C-D23D-C62599DCF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313FB6-7850-297B-E0B3-5D8938ACE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200633-A2EA-33C3-2E60-7E7599165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034ED2-5C30-3E92-5BB4-4352C7A76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5110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809F07-15D1-69FF-BADF-5CA4C4EFB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FCA23B-63BB-2DE2-4119-14EED53527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FBD2AA1-8DFD-B1DA-797F-639630B00C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68DC48-4144-A963-AC60-B95AC2D8E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6A1C5B-60C7-DFEA-DECC-126D11E5A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D55059-6133-98F5-C39C-9BB3E0558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715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1005A2-44BE-C22E-15DF-4C3EEF526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4E40150-6537-738D-4B77-847FA2BC3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E41E0B-9DF0-F574-6438-D583A8ECB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8AD15D7-4C98-81F3-CB1A-1947FDB35A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643FC4-CD9F-124C-D99A-E9F152F934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8CD86D8-5956-A05E-5737-10D323409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D64AC46-A790-29AB-B237-97D3EB32F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E3625DD-FA65-25CD-E83E-E4C98C566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01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95A084-BA29-6F10-8C59-90203A0A1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BDD686A-4B7E-C4D0-E764-EAFAC81C7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2C9339F-0031-4DF2-1866-7DD087635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0779392-1D2B-8B75-70E1-0EC8AD414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201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76DDCBE-C5A2-0AB3-140A-790581005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A822C2E-7258-44F6-55A6-4DF1D3B97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12320CB-7674-EA8E-88EA-2E8EDD443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06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7E9652-5B42-EB02-004D-E62CD1D87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B8D554-9B55-FD4D-94B3-61C3009CAA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F0B5C3D-8C60-B8FE-8212-D8B7AC2F3D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F2890D-2756-E1B3-542E-7FFD4DEA7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8EE334-93EA-DC63-1208-4934EC904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718380-4E2E-1AE3-18FE-2241BBE9F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662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D41EBF-FA4C-8B94-1663-AD51E211F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77BE3F-CB7C-83FB-E560-F871C3A50D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1251ED-1F6C-7637-7AF2-958E78748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FD6624-D097-EC4C-4C57-F701F8A85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616511F-F0E3-0F74-4A12-11713E4D7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E29E36-BC11-218E-047F-5875B07DB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296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77F8417-D51D-74D0-6926-71490EB6B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B5BA0F-CBF2-EAE7-E591-689CCBD49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81CE8E-6945-2F89-71B2-EF80DD4398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807541-6169-305B-2D49-7F1B1B9682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F6F273-2CB4-79D9-1D4B-75A8BD889D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915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29AC6CA0-7A6E-BFED-BD2A-902855FADF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9560429"/>
              </p:ext>
            </p:extLst>
          </p:nvPr>
        </p:nvGraphicFramePr>
        <p:xfrm>
          <a:off x="1344957" y="846171"/>
          <a:ext cx="8704017" cy="3733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691322" imgH="2869936" progId="Prism9.Document">
                  <p:embed/>
                </p:oleObj>
              </mc:Choice>
              <mc:Fallback>
                <p:oleObj name="Prism 9" r:id="rId2" imgW="6691322" imgH="286993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44957" y="846171"/>
                        <a:ext cx="8704017" cy="3733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DAF06D59-37D0-4ADA-08DC-72EEB8224357}"/>
              </a:ext>
            </a:extLst>
          </p:cNvPr>
          <p:cNvSpPr txBox="1"/>
          <p:nvPr/>
        </p:nvSpPr>
        <p:spPr>
          <a:xfrm>
            <a:off x="1074655" y="4579709"/>
            <a:ext cx="9756743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3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other logistic regression model based on cervical lymphadenopathy, LDH, D-Dimer and triglycerides were established. The AUC of ROC curve for this model reached 0.963 (A) and curves of calibration for the logistic regression model was drawn (B)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693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7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rism 9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蔡 丽莎</dc:creator>
  <cp:lastModifiedBy>蔡 丽莎</cp:lastModifiedBy>
  <cp:revision>3</cp:revision>
  <dcterms:created xsi:type="dcterms:W3CDTF">2023-08-29T03:37:14Z</dcterms:created>
  <dcterms:modified xsi:type="dcterms:W3CDTF">2023-09-02T10:16:32Z</dcterms:modified>
</cp:coreProperties>
</file>